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89452" autoAdjust="0"/>
  </p:normalViewPr>
  <p:slideViewPr>
    <p:cSldViewPr snapToGrid="0">
      <p:cViewPr varScale="1">
        <p:scale>
          <a:sx n="109" d="100"/>
          <a:sy n="109" d="100"/>
        </p:scale>
        <p:origin x="216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EB681FF-B227-EA41-678A-D8DB99275C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5062" y="195759"/>
            <a:ext cx="5093237" cy="331497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AB6BBA-D4BE-0CC3-A955-F05EE9EC5E47}"/>
              </a:ext>
            </a:extLst>
          </p:cNvPr>
          <p:cNvSpPr txBox="1"/>
          <p:nvPr/>
        </p:nvSpPr>
        <p:spPr>
          <a:xfrm>
            <a:off x="776532" y="195759"/>
            <a:ext cx="32430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. C1D1 vs PBM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2C52640-2489-B2E8-A8F6-F48F684C2F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5062" y="3510733"/>
            <a:ext cx="5093237" cy="338702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228207F-DFDC-3A15-5E46-10041839B156}"/>
              </a:ext>
            </a:extLst>
          </p:cNvPr>
          <p:cNvSpPr txBox="1"/>
          <p:nvPr/>
        </p:nvSpPr>
        <p:spPr>
          <a:xfrm>
            <a:off x="776532" y="3469590"/>
            <a:ext cx="2153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 C2D5 vs PBMC     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3E2BD1-0E48-C4C3-8D69-66BE58F524A7}"/>
              </a:ext>
            </a:extLst>
          </p:cNvPr>
          <p:cNvSpPr txBox="1"/>
          <p:nvPr/>
        </p:nvSpPr>
        <p:spPr>
          <a:xfrm>
            <a:off x="7416800" y="565091"/>
            <a:ext cx="4165600" cy="47705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Genomic distribution of hypomethylated DMPs in patient PBMCs compared to normal controls.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ie charts of hypomethylated DMPs by CpG island (CGI) position (left panels) and relation to gene category (right panels) for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ycle 1 day 1 (C1D1; pre-treatment) vs. normal PBMCs and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ycle 2 day 5 (C2D5; post-treatment) vs. normal PBMCs. CGI positions include Open Sea (&gt;4 kb from CpG island), Shore (0-2 kb from island), Shelf (2-4 kb from island), and Island regions. Gene categories include intergenic regions, gene body, 5'UTR, TSS1500 (200-1500 bp upstream of transcription start site), TSS200 (0-200 bp upstream of TSS), and 1st exon. DMPs were identified using significance thresholds of p &lt; 0.05 and |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β| &gt; 20%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4165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00</TotalTime>
  <Words>165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Nephew, Kenneth P</cp:lastModifiedBy>
  <cp:revision>101</cp:revision>
  <cp:lastPrinted>2025-11-20T14:34:39Z</cp:lastPrinted>
  <dcterms:created xsi:type="dcterms:W3CDTF">2025-04-15T14:41:30Z</dcterms:created>
  <dcterms:modified xsi:type="dcterms:W3CDTF">2026-02-18T21:09:07Z</dcterms:modified>
</cp:coreProperties>
</file>